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5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 " userId="80018ffaeb1bc28c" providerId="LiveId" clId="{21E56360-091F-40C5-BA37-EA229C0C7D1B}"/>
    <pc:docChg chg="modSld">
      <pc:chgData name=" " userId="80018ffaeb1bc28c" providerId="LiveId" clId="{21E56360-091F-40C5-BA37-EA229C0C7D1B}" dt="2023-07-10T09:26:56.661" v="27" actId="6549"/>
      <pc:docMkLst>
        <pc:docMk/>
      </pc:docMkLst>
      <pc:sldChg chg="modSp mod">
        <pc:chgData name=" " userId="80018ffaeb1bc28c" providerId="LiveId" clId="{21E56360-091F-40C5-BA37-EA229C0C7D1B}" dt="2023-07-10T09:26:56.661" v="27" actId="6549"/>
        <pc:sldMkLst>
          <pc:docMk/>
          <pc:sldMk cId="3907366518" sldId="256"/>
        </pc:sldMkLst>
        <pc:spChg chg="mod">
          <ac:chgData name=" " userId="80018ffaeb1bc28c" providerId="LiveId" clId="{21E56360-091F-40C5-BA37-EA229C0C7D1B}" dt="2023-07-10T09:26:00.076" v="11" actId="20577"/>
          <ac:spMkLst>
            <pc:docMk/>
            <pc:sldMk cId="3907366518" sldId="256"/>
            <ac:spMk id="3" creationId="{00000000-0000-0000-0000-000000000000}"/>
          </ac:spMkLst>
        </pc:spChg>
        <pc:spChg chg="mod">
          <ac:chgData name=" " userId="80018ffaeb1bc28c" providerId="LiveId" clId="{21E56360-091F-40C5-BA37-EA229C0C7D1B}" dt="2023-07-10T09:26:56.661" v="27" actId="6549"/>
          <ac:spMkLst>
            <pc:docMk/>
            <pc:sldMk cId="3907366518" sldId="256"/>
            <ac:spMk id="5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6625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8018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9406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5773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0060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6475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9510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7049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1587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8985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7736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C3A232-A4A9-41FA-92D8-3BAD1954DF63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21385-7EA8-4ABE-A66A-AAC692AE8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3944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324195" y="85635"/>
            <a:ext cx="11604567" cy="18192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49580" indent="449580">
              <a:spcAft>
                <a:spcPts val="800"/>
              </a:spcAft>
            </a:pPr>
            <a:r>
              <a:rPr lang="en-US" sz="1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Score              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Before surgery         6 months                  3 years                   5 years                    10 years	     p value	      p value	       p value	       p value	</a:t>
            </a:r>
            <a:endParaRPr lang="de-DE" sz="10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>
              <a:spcAft>
                <a:spcPts val="800"/>
              </a:spcAft>
            </a:pP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	</a:t>
            </a:r>
            <a:r>
              <a:rPr lang="en-US" sz="1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nge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			                                   (10 years vs. 	      (10 years vs.	      (10 years vs.	       (10 years vs.</a:t>
            </a:r>
            <a:r>
              <a:rPr lang="de-DE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                                                        	____________      ____________      ____________      ____________      ____________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     baseline)	       6months)	      3 years)	       vs. 5 years)</a:t>
            </a:r>
            <a:endParaRPr lang="de-DE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                         	n - Mean (STD)      n   Mean (STD)       n   Mean (STD)      n   Mean (STD)      n   Mean (STD) 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_____________________________________________________________________________________________________________________________________________________________________________</a:t>
            </a:r>
            <a:endParaRPr lang="de-DE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ck depression inventory	0-63	38 - 9 (6.9)	 38 - 6.6 (9.2) 	 31 – 3.8 (6.3) 	31 – 4.7 (7.3) 	31 – 6.6 (7.9)	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&lt;0.1854                         0.9755	         0.1534	         0.3521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ck anxiety inventory score 	0-63	38 – 12.6 (10.7)	 38 - 8.1 (7.3) 	 31 – 6.1 (6.9) 	31 – 7.3 (8.9) 	31 – 9.9 (10.5)	      &lt;0.2026                         0.3657	         0.0753	         0.2141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ttis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mentia rating score	0-144	38 – 136 (15)	 37 - 135 (25) 	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	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	32 – 133 (27)	      &lt;0.82                              0.73	       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	        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de-DE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Rechteck 3"/>
          <p:cNvSpPr/>
          <p:nvPr/>
        </p:nvSpPr>
        <p:spPr>
          <a:xfrm>
            <a:off x="323272" y="3925456"/>
            <a:ext cx="11734800" cy="272888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49580" indent="449580"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cholinergics	 	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40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9 (23)	 40 - 3 (8) 	 31 – 1 (3) 	32 – 0 (0) 	31 – 0 (0)	     0.002	     0.150	    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	    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zodiazepines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40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14 (35)	 40 - 11 (28) 	 31 – 7 (23) 	32 – 6 (19) 	31 – 9 (29)	     1.0	     0.195	     0.001	     0.036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spastics		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4 (10)	 40 - 2 (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	 31 – 0 (0) 	32 – 1 (3) 	31 – 0 (0)	     0.076	     0.150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uroleptics		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4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4 (10)	 40 - 0 (0)	 31 – 0 (0) 	32 – 0 (0)	31 – 1 (3)	     0.076	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0.076 	     0.105	    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trabenazine	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40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5 (13)	 40 -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5)	 31 - 1 (3) 	32 – 1 (3)	31 – 0 (0)	     0.010	    0.076	     0.149	     0.310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vodopa/DDCI		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2 (5)	 39 - 1 (3)	 31 – 0 (0) 	32 – 0 (0)	31 – 0 (0)	     0.149	    0.316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.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getics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	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9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4 (10)	 39 – 1 (3)	 31 – 1 (3) 	32 – 2 (6)	31 – 6 (6)	     1.0	    0.2	     0.2	    1.0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depressants	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- 7 (18)	 40 – 1 (3)	 31 – 3 (10) 	32 – 3 (9)	31 – 5 (5)	     0.127	    0.172	     0.005	    0.309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rathecal baclofen	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- 2 (5)	 40 – 0 (0)	 31 – 0 (0) 	32 – 0 (0)	31 – 0 (0)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	    0.316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.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tuinum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xine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jection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- 14 (35)	 40 – 5 (13)	 31 -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10) 	32 – 7 (23)	31 – 5 (5)	     0.3	    0.3	     0.63	     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.099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342669" y="2658731"/>
            <a:ext cx="11563004" cy="9928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imulation-Amplitude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V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       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–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9 - 3.5 (1.8)               30 – 3.5 (0.7)             31 – 3.2 (0.8)            31 – 3.3 (0.8)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	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.03	         0.29	           0.93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imulation-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lse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dth (µs)	                            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–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39 - 125.0 (39.0)        30 – 124.3 (33.9)      31 – 129.0 (35.7)     31 – 117.3 (44.4)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          &lt;0.001	         0.16	           0.84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imulation-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equency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Hz)                                    </a:t>
            </a:r>
            <a:r>
              <a:rPr lang="en-US" sz="9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–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9 – 146.9 (28.9)        30 – 162.2 (31.7)      31 – 162.9 (34.9)     31 – 163.9 (34.4)	     </a:t>
            </a:r>
            <a:r>
              <a:rPr lang="en-US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	          0.1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         0.02	           &lt;0.001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</a:t>
            </a:r>
            <a:endParaRPr lang="de-DE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 flipH="1">
            <a:off x="333427" y="120070"/>
            <a:ext cx="16339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/>
              <a:t>Scores</a:t>
            </a:r>
            <a:r>
              <a:rPr lang="de-DE" sz="1600" dirty="0" smtClean="0"/>
              <a:t> </a:t>
            </a:r>
            <a:endParaRPr lang="de-DE" sz="1600" dirty="0"/>
          </a:p>
        </p:txBody>
      </p:sp>
      <p:sp>
        <p:nvSpPr>
          <p:cNvPr id="8" name="Textfeld 7"/>
          <p:cNvSpPr txBox="1"/>
          <p:nvPr/>
        </p:nvSpPr>
        <p:spPr>
          <a:xfrm flipH="1">
            <a:off x="342668" y="2089226"/>
            <a:ext cx="35181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/>
              <a:t>Stimulation Parameters</a:t>
            </a:r>
            <a:r>
              <a:rPr lang="de-DE" sz="1600" dirty="0" smtClean="0"/>
              <a:t> </a:t>
            </a:r>
            <a:endParaRPr lang="de-DE" sz="1600" dirty="0"/>
          </a:p>
        </p:txBody>
      </p:sp>
      <p:sp>
        <p:nvSpPr>
          <p:cNvPr id="9" name="Textfeld 8"/>
          <p:cNvSpPr txBox="1"/>
          <p:nvPr/>
        </p:nvSpPr>
        <p:spPr>
          <a:xfrm flipH="1">
            <a:off x="342669" y="3558845"/>
            <a:ext cx="19110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/>
              <a:t>Medication</a:t>
            </a:r>
            <a:r>
              <a:rPr lang="de-DE" sz="1600" dirty="0" smtClean="0"/>
              <a:t> </a:t>
            </a:r>
            <a:endParaRPr lang="de-DE" sz="1600" dirty="0"/>
          </a:p>
        </p:txBody>
      </p:sp>
      <p:sp>
        <p:nvSpPr>
          <p:cNvPr id="10" name="Textfeld 9"/>
          <p:cNvSpPr txBox="1"/>
          <p:nvPr/>
        </p:nvSpPr>
        <p:spPr>
          <a:xfrm>
            <a:off x="341754" y="1948866"/>
            <a:ext cx="12247412" cy="922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49580" indent="449580">
              <a:spcAft>
                <a:spcPts val="800"/>
              </a:spcAft>
            </a:pPr>
            <a:r>
              <a:rPr lang="de-DE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	____________      </a:t>
            </a:r>
            <a:r>
              <a:rPr lang="de-DE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____________      ____________      ____________      ____________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endParaRPr lang="de-DE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n - Mean (STD)      n   Mean (STD)       n   Mean (STD)      n   Mean (STD)      n   Mean (STD) _____________________________________________________________________________________________________________________________________________________________________________</a:t>
            </a:r>
            <a:endParaRPr lang="de-DE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000" dirty="0"/>
          </a:p>
        </p:txBody>
      </p:sp>
      <p:sp>
        <p:nvSpPr>
          <p:cNvPr id="11" name="Textfeld 10"/>
          <p:cNvSpPr txBox="1"/>
          <p:nvPr/>
        </p:nvSpPr>
        <p:spPr>
          <a:xfrm>
            <a:off x="314046" y="3420842"/>
            <a:ext cx="12247409" cy="922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49580" indent="449580">
              <a:spcAft>
                <a:spcPts val="800"/>
              </a:spcAft>
            </a:pPr>
            <a:r>
              <a:rPr lang="de-DE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	____________     ____________      </a:t>
            </a:r>
            <a:r>
              <a:rPr lang="de-DE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____________     </a:t>
            </a:r>
            <a:r>
              <a:rPr lang="de-DE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____________      </a:t>
            </a:r>
            <a:r>
              <a:rPr lang="de-DE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____________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endParaRPr lang="de-DE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       total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– n (%)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total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– n (%) 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total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– n (%)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total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– n (%)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total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 – n (%)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_____________________________________________________________________________________________________________________________________________________________________________</a:t>
            </a:r>
            <a:endParaRPr lang="de-DE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000" dirty="0"/>
          </a:p>
        </p:txBody>
      </p:sp>
    </p:spTree>
    <p:extLst>
      <p:ext uri="{BB962C8B-B14F-4D97-AF65-F5344CB8AC3E}">
        <p14:creationId xmlns:p14="http://schemas.microsoft.com/office/powerpoint/2010/main" val="3907366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9</Words>
  <Application>Microsoft Office PowerPoint</Application>
  <PresentationFormat>Breitbild</PresentationFormat>
  <Paragraphs>2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rause, Patricia</dc:creator>
  <cp:lastModifiedBy>Krause, Patricia</cp:lastModifiedBy>
  <cp:revision>29</cp:revision>
  <dcterms:created xsi:type="dcterms:W3CDTF">2023-03-02T13:12:48Z</dcterms:created>
  <dcterms:modified xsi:type="dcterms:W3CDTF">2024-09-29T10:50:29Z</dcterms:modified>
</cp:coreProperties>
</file>